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46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5971B-D9A3-4093-A95D-AA462D5A9B28}" type="datetimeFigureOut">
              <a:rPr lang="en-GB" smtClean="0"/>
              <a:pPr/>
              <a:t>23/04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E77C5-B693-4551-895D-0CF9938AE8C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5971B-D9A3-4093-A95D-AA462D5A9B28}" type="datetimeFigureOut">
              <a:rPr lang="en-GB" smtClean="0"/>
              <a:pPr/>
              <a:t>23/04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E77C5-B693-4551-895D-0CF9938AE8C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5971B-D9A3-4093-A95D-AA462D5A9B28}" type="datetimeFigureOut">
              <a:rPr lang="en-GB" smtClean="0"/>
              <a:pPr/>
              <a:t>23/04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E77C5-B693-4551-895D-0CF9938AE8C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5971B-D9A3-4093-A95D-AA462D5A9B28}" type="datetimeFigureOut">
              <a:rPr lang="en-GB" smtClean="0"/>
              <a:pPr/>
              <a:t>23/04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E77C5-B693-4551-895D-0CF9938AE8C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5971B-D9A3-4093-A95D-AA462D5A9B28}" type="datetimeFigureOut">
              <a:rPr lang="en-GB" smtClean="0"/>
              <a:pPr/>
              <a:t>23/04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E77C5-B693-4551-895D-0CF9938AE8C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5971B-D9A3-4093-A95D-AA462D5A9B28}" type="datetimeFigureOut">
              <a:rPr lang="en-GB" smtClean="0"/>
              <a:pPr/>
              <a:t>23/04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E77C5-B693-4551-895D-0CF9938AE8C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5971B-D9A3-4093-A95D-AA462D5A9B28}" type="datetimeFigureOut">
              <a:rPr lang="en-GB" smtClean="0"/>
              <a:pPr/>
              <a:t>23/04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E77C5-B693-4551-895D-0CF9938AE8C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5971B-D9A3-4093-A95D-AA462D5A9B28}" type="datetimeFigureOut">
              <a:rPr lang="en-GB" smtClean="0"/>
              <a:pPr/>
              <a:t>23/04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E77C5-B693-4551-895D-0CF9938AE8C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5971B-D9A3-4093-A95D-AA462D5A9B28}" type="datetimeFigureOut">
              <a:rPr lang="en-GB" smtClean="0"/>
              <a:pPr/>
              <a:t>23/04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E77C5-B693-4551-895D-0CF9938AE8C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5971B-D9A3-4093-A95D-AA462D5A9B28}" type="datetimeFigureOut">
              <a:rPr lang="en-GB" smtClean="0"/>
              <a:pPr/>
              <a:t>23/04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E77C5-B693-4551-895D-0CF9938AE8C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55971B-D9A3-4093-A95D-AA462D5A9B28}" type="datetimeFigureOut">
              <a:rPr lang="en-GB" smtClean="0"/>
              <a:pPr/>
              <a:t>23/04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1E77C5-B693-4551-895D-0CF9938AE8CC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5971B-D9A3-4093-A95D-AA462D5A9B28}" type="datetimeFigureOut">
              <a:rPr lang="en-GB" smtClean="0"/>
              <a:pPr/>
              <a:t>23/04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1E77C5-B693-4551-895D-0CF9938AE8CC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78.jpeg"/><Relationship Id="rId3" Type="http://schemas.openxmlformats.org/officeDocument/2006/relationships/image" Target="../media/image73.jpeg"/><Relationship Id="rId7" Type="http://schemas.openxmlformats.org/officeDocument/2006/relationships/image" Target="../media/image77.jpeg"/><Relationship Id="rId2" Type="http://schemas.openxmlformats.org/officeDocument/2006/relationships/image" Target="../media/image72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6.jpeg"/><Relationship Id="rId5" Type="http://schemas.openxmlformats.org/officeDocument/2006/relationships/image" Target="../media/image75.jpeg"/><Relationship Id="rId10" Type="http://schemas.openxmlformats.org/officeDocument/2006/relationships/image" Target="../media/image80.jpeg"/><Relationship Id="rId4" Type="http://schemas.openxmlformats.org/officeDocument/2006/relationships/image" Target="../media/image74.jpeg"/><Relationship Id="rId9" Type="http://schemas.openxmlformats.org/officeDocument/2006/relationships/image" Target="../media/image79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4" Type="http://schemas.openxmlformats.org/officeDocument/2006/relationships/image" Target="../media/image11.jpeg"/><Relationship Id="rId9" Type="http://schemas.openxmlformats.org/officeDocument/2006/relationships/image" Target="../media/image16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3" Type="http://schemas.openxmlformats.org/officeDocument/2006/relationships/image" Target="../media/image18.jpeg"/><Relationship Id="rId7" Type="http://schemas.openxmlformats.org/officeDocument/2006/relationships/image" Target="../media/image22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jpeg"/><Relationship Id="rId5" Type="http://schemas.openxmlformats.org/officeDocument/2006/relationships/image" Target="../media/image20.jpeg"/><Relationship Id="rId4" Type="http://schemas.openxmlformats.org/officeDocument/2006/relationships/image" Target="../media/image19.jpeg"/><Relationship Id="rId9" Type="http://schemas.openxmlformats.org/officeDocument/2006/relationships/image" Target="../media/image24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jpeg"/><Relationship Id="rId3" Type="http://schemas.openxmlformats.org/officeDocument/2006/relationships/image" Target="../media/image26.jpeg"/><Relationship Id="rId7" Type="http://schemas.openxmlformats.org/officeDocument/2006/relationships/image" Target="../media/image30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jpeg"/><Relationship Id="rId5" Type="http://schemas.openxmlformats.org/officeDocument/2006/relationships/image" Target="../media/image28.jpeg"/><Relationship Id="rId4" Type="http://schemas.openxmlformats.org/officeDocument/2006/relationships/image" Target="../media/image27.jpeg"/><Relationship Id="rId9" Type="http://schemas.openxmlformats.org/officeDocument/2006/relationships/image" Target="../media/image32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jpeg"/><Relationship Id="rId3" Type="http://schemas.openxmlformats.org/officeDocument/2006/relationships/image" Target="../media/image34.jpeg"/><Relationship Id="rId7" Type="http://schemas.openxmlformats.org/officeDocument/2006/relationships/image" Target="../media/image38.jpeg"/><Relationship Id="rId2" Type="http://schemas.openxmlformats.org/officeDocument/2006/relationships/image" Target="../media/image33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7.jpeg"/><Relationship Id="rId5" Type="http://schemas.openxmlformats.org/officeDocument/2006/relationships/image" Target="../media/image36.jpeg"/><Relationship Id="rId4" Type="http://schemas.openxmlformats.org/officeDocument/2006/relationships/image" Target="../media/image35.jpeg"/><Relationship Id="rId9" Type="http://schemas.openxmlformats.org/officeDocument/2006/relationships/image" Target="../media/image40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jpeg"/><Relationship Id="rId3" Type="http://schemas.openxmlformats.org/officeDocument/2006/relationships/image" Target="../media/image42.jpeg"/><Relationship Id="rId7" Type="http://schemas.openxmlformats.org/officeDocument/2006/relationships/image" Target="../media/image46.jpeg"/><Relationship Id="rId2" Type="http://schemas.openxmlformats.org/officeDocument/2006/relationships/image" Target="../media/image4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5.jpeg"/><Relationship Id="rId5" Type="http://schemas.openxmlformats.org/officeDocument/2006/relationships/image" Target="../media/image44.jpeg"/><Relationship Id="rId4" Type="http://schemas.openxmlformats.org/officeDocument/2006/relationships/image" Target="../media/image43.jpeg"/><Relationship Id="rId9" Type="http://schemas.openxmlformats.org/officeDocument/2006/relationships/image" Target="../media/image48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jpeg"/><Relationship Id="rId3" Type="http://schemas.openxmlformats.org/officeDocument/2006/relationships/image" Target="../media/image50.jpeg"/><Relationship Id="rId7" Type="http://schemas.openxmlformats.org/officeDocument/2006/relationships/image" Target="../media/image54.jpeg"/><Relationship Id="rId2" Type="http://schemas.openxmlformats.org/officeDocument/2006/relationships/image" Target="../media/image4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3.jpeg"/><Relationship Id="rId5" Type="http://schemas.openxmlformats.org/officeDocument/2006/relationships/image" Target="../media/image52.jpeg"/><Relationship Id="rId4" Type="http://schemas.openxmlformats.org/officeDocument/2006/relationships/image" Target="../media/image51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jpeg"/><Relationship Id="rId3" Type="http://schemas.openxmlformats.org/officeDocument/2006/relationships/image" Target="../media/image57.jpeg"/><Relationship Id="rId7" Type="http://schemas.openxmlformats.org/officeDocument/2006/relationships/image" Target="../media/image61.jpeg"/><Relationship Id="rId2" Type="http://schemas.openxmlformats.org/officeDocument/2006/relationships/image" Target="../media/image56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0.jpeg"/><Relationship Id="rId5" Type="http://schemas.openxmlformats.org/officeDocument/2006/relationships/image" Target="../media/image59.jpeg"/><Relationship Id="rId4" Type="http://schemas.openxmlformats.org/officeDocument/2006/relationships/image" Target="../media/image58.jpeg"/><Relationship Id="rId9" Type="http://schemas.openxmlformats.org/officeDocument/2006/relationships/image" Target="../media/image63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jpeg"/><Relationship Id="rId3" Type="http://schemas.openxmlformats.org/officeDocument/2006/relationships/image" Target="../media/image65.jpeg"/><Relationship Id="rId7" Type="http://schemas.openxmlformats.org/officeDocument/2006/relationships/image" Target="../media/image69.jpeg"/><Relationship Id="rId2" Type="http://schemas.openxmlformats.org/officeDocument/2006/relationships/image" Target="../media/image64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8.jpeg"/><Relationship Id="rId5" Type="http://schemas.openxmlformats.org/officeDocument/2006/relationships/image" Target="../media/image67.jpeg"/><Relationship Id="rId4" Type="http://schemas.openxmlformats.org/officeDocument/2006/relationships/image" Target="../media/image66.jpeg"/><Relationship Id="rId9" Type="http://schemas.openxmlformats.org/officeDocument/2006/relationships/image" Target="../media/image7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84921"/>
            <a:ext cx="7772400" cy="1470025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40696"/>
            <a:ext cx="6400800" cy="1752600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3347864" y="35332"/>
            <a:ext cx="2149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Large fresh granule 1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539552" y="476672"/>
            <a:ext cx="178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/ </a:t>
            </a:r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Hi = ACC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6660232" y="476672"/>
            <a:ext cx="1943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carbonate peak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491880" y="476672"/>
            <a:ext cx="164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calcite peak</a:t>
            </a:r>
            <a:endParaRPr lang="en-GB" dirty="0"/>
          </a:p>
        </p:txBody>
      </p:sp>
      <p:pic>
        <p:nvPicPr>
          <p:cNvPr id="4" name="Picture 2" descr="X:\2014\sm9197-1\processing\Processed maps CaCO3\EW7 large fresh granule 1 whole granule\EW7 fresh large granule 1 716 to 695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771800" y="836712"/>
            <a:ext cx="3024378" cy="2173986"/>
          </a:xfrm>
          <a:prstGeom prst="rect">
            <a:avLst/>
          </a:prstGeom>
          <a:noFill/>
        </p:spPr>
      </p:pic>
      <p:pic>
        <p:nvPicPr>
          <p:cNvPr id="1026" name="Picture 2" descr="X:\2014\sm9197-1\processing\Processed maps CaCO3\EW7 large fresh granule 1 whole granule\EW7 fresh large granule 1 855 to 890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012160" y="908720"/>
            <a:ext cx="2898248" cy="2083321"/>
          </a:xfrm>
          <a:prstGeom prst="rect">
            <a:avLst/>
          </a:prstGeom>
          <a:noFill/>
        </p:spPr>
      </p:pic>
      <p:pic>
        <p:nvPicPr>
          <p:cNvPr id="5122" name="Picture 2" descr="X:\2014\sm9197-1\processing\Processed maps CaCO3\EW7 large fresh granule 1 whole granule\EW7 fresh large granule 1 3 clusters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0" y="2996952"/>
            <a:ext cx="2116287" cy="2030363"/>
          </a:xfrm>
          <a:prstGeom prst="rect">
            <a:avLst/>
          </a:prstGeom>
          <a:noFill/>
        </p:spPr>
      </p:pic>
      <p:pic>
        <p:nvPicPr>
          <p:cNvPr id="5123" name="Picture 3" descr="X:\2014\sm9197-1\processing\Processed maps CaCO3\EW7 large fresh granule 1 whole granule\EW7 fresh large granule 1 6 clusters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123728" y="2996952"/>
            <a:ext cx="2176605" cy="2088232"/>
          </a:xfrm>
          <a:prstGeom prst="rect">
            <a:avLst/>
          </a:prstGeom>
          <a:noFill/>
        </p:spPr>
      </p:pic>
      <p:sp>
        <p:nvSpPr>
          <p:cNvPr id="14" name="TextBox 13"/>
          <p:cNvSpPr txBox="1"/>
          <p:nvPr/>
        </p:nvSpPr>
        <p:spPr>
          <a:xfrm>
            <a:off x="5508104" y="5085184"/>
            <a:ext cx="562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CC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7596336" y="5085184"/>
            <a:ext cx="81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alcite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5868144" y="5445224"/>
            <a:ext cx="2314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omponent regression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1043608" y="5445224"/>
            <a:ext cx="1619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luster analysis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611560" y="5085184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3 clusters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2915816" y="5013176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6 clusters</a:t>
            </a:r>
            <a:endParaRPr lang="en-GB" dirty="0"/>
          </a:p>
        </p:txBody>
      </p:sp>
      <p:pic>
        <p:nvPicPr>
          <p:cNvPr id="5" name="Picture 2" descr="X:\2014\sm9197-1\processing\Processed maps CaCO3\EW7 large fresh granule 1 whole granule\EW7 fresh large granule 1 component regression ACC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283968" y="2996952"/>
            <a:ext cx="2176605" cy="2088232"/>
          </a:xfrm>
          <a:prstGeom prst="rect">
            <a:avLst/>
          </a:prstGeom>
          <a:noFill/>
        </p:spPr>
      </p:pic>
      <p:pic>
        <p:nvPicPr>
          <p:cNvPr id="6" name="Picture 3" descr="X:\2014\sm9197-1\processing\Processed maps CaCO3\EW7 large fresh granule 1 whole granule\EW7 fresh large granule 1 component regression calcite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6444208" y="2996952"/>
            <a:ext cx="2153694" cy="2088232"/>
          </a:xfrm>
          <a:prstGeom prst="rect">
            <a:avLst/>
          </a:prstGeom>
          <a:noFill/>
        </p:spPr>
      </p:pic>
      <p:pic>
        <p:nvPicPr>
          <p:cNvPr id="1030" name="Picture 6" descr="X:\2014\sm9197-1\processing\Processed maps CaCO3\EW7 large fresh granule 1 whole granule\EW7 fresh large granule 1 v2v4ratio 2nd version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67544" y="836712"/>
            <a:ext cx="2232248" cy="2141615"/>
          </a:xfrm>
          <a:prstGeom prst="rect">
            <a:avLst/>
          </a:prstGeom>
          <a:noFill/>
        </p:spPr>
      </p:pic>
      <p:pic>
        <p:nvPicPr>
          <p:cNvPr id="3074" name="Picture 2" descr="X:\2014\sm9197-1\processing\Processed maps CaCO3\EW7 large fresh granule 1 whole granule\EW7 fresh large granule 1 overview showing full mapped area with grid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067944" y="5229200"/>
            <a:ext cx="1405533" cy="1362811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84921"/>
            <a:ext cx="7772400" cy="1470025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40696"/>
            <a:ext cx="6400800" cy="1752600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3347864" y="35332"/>
            <a:ext cx="2096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ld granule 2 centre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539552" y="476672"/>
            <a:ext cx="178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/ </a:t>
            </a:r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Hi = ACC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6660232" y="476672"/>
            <a:ext cx="1943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carbonate peak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491880" y="476672"/>
            <a:ext cx="164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calcite peak</a:t>
            </a:r>
            <a:endParaRPr lang="en-GB" dirty="0"/>
          </a:p>
        </p:txBody>
      </p:sp>
      <p:sp>
        <p:nvSpPr>
          <p:cNvPr id="14" name="TextBox 13"/>
          <p:cNvSpPr txBox="1"/>
          <p:nvPr/>
        </p:nvSpPr>
        <p:spPr>
          <a:xfrm>
            <a:off x="5652120" y="4797152"/>
            <a:ext cx="562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CC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7884368" y="4869160"/>
            <a:ext cx="81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alcite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6588224" y="5301208"/>
            <a:ext cx="2314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omponent regression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1368726" y="5517232"/>
            <a:ext cx="1619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luster analysis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611560" y="5301208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3 clusters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2915816" y="5229200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4 clusters</a:t>
            </a:r>
            <a:endParaRPr lang="en-GB" dirty="0"/>
          </a:p>
        </p:txBody>
      </p:sp>
      <p:pic>
        <p:nvPicPr>
          <p:cNvPr id="1026" name="Picture 2" descr="X:\2014\sm9197-1\processing\Processed maps CaCO3\EW7 old granule 2 centre\EW7 old granule 2 middle section with grid for HR map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851920" y="5373216"/>
            <a:ext cx="1224136" cy="1186928"/>
          </a:xfrm>
          <a:prstGeom prst="rect">
            <a:avLst/>
          </a:prstGeom>
          <a:noFill/>
        </p:spPr>
      </p:pic>
      <p:pic>
        <p:nvPicPr>
          <p:cNvPr id="1027" name="Picture 3" descr="X:\2014\sm9197-1\processing\Processed maps CaCO3\EW7 old granule 2 centre\EW7 old granule 2 middle v2v4 ratio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67544" y="908720"/>
            <a:ext cx="2230958" cy="2140378"/>
          </a:xfrm>
          <a:prstGeom prst="rect">
            <a:avLst/>
          </a:prstGeom>
          <a:noFill/>
        </p:spPr>
      </p:pic>
      <p:pic>
        <p:nvPicPr>
          <p:cNvPr id="1028" name="Picture 4" descr="X:\2014\sm9197-1\processing\Processed maps CaCO3\EW7 old granule 2 centre\EW7 old granule 2 middle 716 to 695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131840" y="764704"/>
            <a:ext cx="2374974" cy="2278546"/>
          </a:xfrm>
          <a:prstGeom prst="rect">
            <a:avLst/>
          </a:prstGeom>
          <a:noFill/>
        </p:spPr>
      </p:pic>
      <p:pic>
        <p:nvPicPr>
          <p:cNvPr id="1029" name="Picture 5" descr="X:\2014\sm9197-1\processing\Processed maps CaCO3\EW7 old granule 2 centre\EW7 old granule 2 middle 890 to 855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372200" y="836712"/>
            <a:ext cx="2376264" cy="2279784"/>
          </a:xfrm>
          <a:prstGeom prst="rect">
            <a:avLst/>
          </a:prstGeom>
          <a:noFill/>
        </p:spPr>
      </p:pic>
      <p:pic>
        <p:nvPicPr>
          <p:cNvPr id="1030" name="Picture 6" descr="X:\2014\sm9197-1\processing\Processed maps CaCO3\EW7 old granule 2 centre\EW7 old granule 2 middle 3 clusters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95536" y="3068960"/>
            <a:ext cx="2341454" cy="2246387"/>
          </a:xfrm>
          <a:prstGeom prst="rect">
            <a:avLst/>
          </a:prstGeom>
          <a:noFill/>
        </p:spPr>
      </p:pic>
      <p:pic>
        <p:nvPicPr>
          <p:cNvPr id="1031" name="Picture 7" descr="X:\2014\sm9197-1\processing\Processed maps CaCO3\EW7 old granule 2 centre\EW7 old granule 2 middle 4 clusters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771800" y="3140968"/>
            <a:ext cx="2302966" cy="2209462"/>
          </a:xfrm>
          <a:prstGeom prst="rect">
            <a:avLst/>
          </a:prstGeom>
          <a:noFill/>
        </p:spPr>
      </p:pic>
      <p:pic>
        <p:nvPicPr>
          <p:cNvPr id="1032" name="Picture 8" descr="X:\2014\sm9197-1\processing\Processed maps CaCO3\EW7 old granule 2 centre\EW7 old granule 2 middle component regression ACC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5148064" y="3212976"/>
            <a:ext cx="1501107" cy="1440160"/>
          </a:xfrm>
          <a:prstGeom prst="rect">
            <a:avLst/>
          </a:prstGeom>
          <a:noFill/>
        </p:spPr>
      </p:pic>
      <p:pic>
        <p:nvPicPr>
          <p:cNvPr id="1033" name="Picture 9" descr="X:\2014\sm9197-1\processing\Processed maps CaCO3\EW7 old granule 2 centre\EW7 old granule 2 middle component regression calcite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7489106" y="3212976"/>
            <a:ext cx="1654894" cy="1587703"/>
          </a:xfrm>
          <a:prstGeom prst="rect">
            <a:avLst/>
          </a:prstGeom>
          <a:noFill/>
        </p:spPr>
      </p:pic>
      <p:pic>
        <p:nvPicPr>
          <p:cNvPr id="1034" name="Picture 10" descr="X:\2014\sm9197-1\processing\Processed maps CaCO3\EW7 old granule 2 centre\EW7 old granule 2 middle component regression ACC version 2.jpg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5292080" y="5085184"/>
            <a:ext cx="1372958" cy="1317214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84921"/>
            <a:ext cx="7772400" cy="1470025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40696"/>
            <a:ext cx="6400800" cy="1752600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3347864" y="35332"/>
            <a:ext cx="2557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Large fresh granule 1 NW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539552" y="476672"/>
            <a:ext cx="178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/ </a:t>
            </a:r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Hi = ACC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6660232" y="476672"/>
            <a:ext cx="1943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carbonate peak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491880" y="476672"/>
            <a:ext cx="164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calcite peak</a:t>
            </a:r>
            <a:endParaRPr lang="en-GB" dirty="0"/>
          </a:p>
        </p:txBody>
      </p:sp>
      <p:pic>
        <p:nvPicPr>
          <p:cNvPr id="2053" name="Picture 5" descr="X:\2014\sm9197-1\processing\Processed maps CaCO3\EW7 large fresh granule 1 NW corner\EW7 large granule 1 (NW corner) for HR map with grid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419872" y="5373216"/>
            <a:ext cx="1728192" cy="1260947"/>
          </a:xfrm>
          <a:prstGeom prst="rect">
            <a:avLst/>
          </a:prstGeom>
          <a:noFill/>
        </p:spPr>
      </p:pic>
      <p:sp>
        <p:nvSpPr>
          <p:cNvPr id="14" name="TextBox 13"/>
          <p:cNvSpPr txBox="1"/>
          <p:nvPr/>
        </p:nvSpPr>
        <p:spPr>
          <a:xfrm>
            <a:off x="5508104" y="5085184"/>
            <a:ext cx="562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CC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7596336" y="5085184"/>
            <a:ext cx="81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alcite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5868144" y="5445224"/>
            <a:ext cx="2314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omponent regression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1043608" y="5445224"/>
            <a:ext cx="1619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luster analysis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611560" y="5085184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3 clusters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2915816" y="5013176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4 clusters</a:t>
            </a:r>
            <a:endParaRPr lang="en-GB" dirty="0"/>
          </a:p>
        </p:txBody>
      </p:sp>
      <p:pic>
        <p:nvPicPr>
          <p:cNvPr id="4099" name="Picture 3" descr="X:\2014\sm9197-1\processing\Processed maps CaCO3\EW7 large fresh granule 1 NW corner\EW7 large granule 1 NW corner v2 to v4 ratio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95536" y="836712"/>
            <a:ext cx="2230958" cy="2140378"/>
          </a:xfrm>
          <a:prstGeom prst="rect">
            <a:avLst/>
          </a:prstGeom>
          <a:noFill/>
        </p:spPr>
      </p:pic>
      <p:pic>
        <p:nvPicPr>
          <p:cNvPr id="4100" name="Picture 4" descr="X:\2014\sm9197-1\processing\Processed maps CaCO3\EW7 large fresh granule 1 NW corner\EW7 large granule 1 NW corner 716 to 695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419872" y="836712"/>
            <a:ext cx="2251660" cy="2160240"/>
          </a:xfrm>
          <a:prstGeom prst="rect">
            <a:avLst/>
          </a:prstGeom>
          <a:noFill/>
        </p:spPr>
      </p:pic>
      <p:pic>
        <p:nvPicPr>
          <p:cNvPr id="4101" name="Picture 5" descr="X:\2014\sm9197-1\processing\Processed maps CaCO3\EW7 large fresh granule 1 NW corner\EW7 large granule 1 NW corner 890 to 855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300192" y="836712"/>
            <a:ext cx="2176606" cy="2088232"/>
          </a:xfrm>
          <a:prstGeom prst="rect">
            <a:avLst/>
          </a:prstGeom>
          <a:noFill/>
        </p:spPr>
      </p:pic>
      <p:pic>
        <p:nvPicPr>
          <p:cNvPr id="4102" name="Picture 6" descr="X:\2014\sm9197-1\processing\Processed maps CaCO3\EW7 large fresh granule 1 NW corner\EW&amp; large granule 1 NW corner 3 clusters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95536" y="2996952"/>
            <a:ext cx="2014934" cy="1933125"/>
          </a:xfrm>
          <a:prstGeom prst="rect">
            <a:avLst/>
          </a:prstGeom>
          <a:noFill/>
        </p:spPr>
      </p:pic>
      <p:pic>
        <p:nvPicPr>
          <p:cNvPr id="4103" name="Picture 7" descr="X:\2014\sm9197-1\processing\Processed maps CaCO3\EW7 large fresh granule 1 NW corner\EW&amp; large granule 1 NW corner 4 clusters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411760" y="2996952"/>
            <a:ext cx="2086942" cy="2002209"/>
          </a:xfrm>
          <a:prstGeom prst="rect">
            <a:avLst/>
          </a:prstGeom>
          <a:noFill/>
        </p:spPr>
      </p:pic>
      <p:pic>
        <p:nvPicPr>
          <p:cNvPr id="4104" name="Picture 8" descr="X:\2014\sm9197-1\processing\Processed maps CaCO3\EW7 large fresh granule 1 NW corner\EW&amp; large granule 1 NW corner component regression ACC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572000" y="2996952"/>
            <a:ext cx="2014934" cy="1933125"/>
          </a:xfrm>
          <a:prstGeom prst="rect">
            <a:avLst/>
          </a:prstGeom>
          <a:noFill/>
        </p:spPr>
      </p:pic>
      <p:pic>
        <p:nvPicPr>
          <p:cNvPr id="4105" name="Picture 9" descr="X:\2014\sm9197-1\processing\Processed maps CaCO3\EW7 large fresh granule 1 NW corner\EW&amp; large granule 1 NW corner component regression calcite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6516216" y="2996952"/>
            <a:ext cx="2026494" cy="1944216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84921"/>
            <a:ext cx="7772400" cy="1470025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40696"/>
            <a:ext cx="6400800" cy="1752600"/>
          </a:xfrm>
        </p:spPr>
        <p:txBody>
          <a:bodyPr/>
          <a:lstStyle/>
          <a:p>
            <a:endParaRPr lang="en-GB" dirty="0"/>
          </a:p>
        </p:txBody>
      </p:sp>
      <p:pic>
        <p:nvPicPr>
          <p:cNvPr id="1026" name="Picture 2" descr="X:\2014\sm9197-1\processing\Processed maps CaCO3\EW7 large fresh granule 1 SE corner\EW7 fresh large granule 1 SE corner v2v4 ratio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859160"/>
            <a:ext cx="3024378" cy="2173986"/>
          </a:xfrm>
          <a:prstGeom prst="rect">
            <a:avLst/>
          </a:prstGeom>
          <a:noFill/>
        </p:spPr>
      </p:pic>
      <p:pic>
        <p:nvPicPr>
          <p:cNvPr id="1027" name="Picture 3" descr="X:\2014\sm9197-1\processing\Processed maps CaCO3\EW7 large fresh granule 1 SE corner\EW7 fresh large granule 1 SE corner 716 to 695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059832" y="859160"/>
            <a:ext cx="3024378" cy="2173986"/>
          </a:xfrm>
          <a:prstGeom prst="rect">
            <a:avLst/>
          </a:prstGeom>
          <a:noFill/>
        </p:spPr>
      </p:pic>
      <p:pic>
        <p:nvPicPr>
          <p:cNvPr id="1028" name="Picture 4" descr="X:\2014\sm9197-1\processing\Processed maps CaCO3\EW7 large fresh granule 1 SE corner\EW7 large granule 1 SE corner 890 to 855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119622" y="859160"/>
            <a:ext cx="3024378" cy="2173986"/>
          </a:xfrm>
          <a:prstGeom prst="rect">
            <a:avLst/>
          </a:prstGeom>
          <a:noFill/>
        </p:spPr>
      </p:pic>
      <p:pic>
        <p:nvPicPr>
          <p:cNvPr id="1029" name="Picture 5" descr="X:\2014\sm9197-1\processing\Processed maps CaCO3\EW7 large fresh granule 1 SE corner\EW7 fresh large granule 1 SE corner grid for HR map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275856" y="5301208"/>
            <a:ext cx="1656184" cy="1385302"/>
          </a:xfrm>
          <a:prstGeom prst="rect">
            <a:avLst/>
          </a:prstGeom>
          <a:noFill/>
        </p:spPr>
      </p:pic>
      <p:sp>
        <p:nvSpPr>
          <p:cNvPr id="8" name="TextBox 7"/>
          <p:cNvSpPr txBox="1"/>
          <p:nvPr/>
        </p:nvSpPr>
        <p:spPr>
          <a:xfrm>
            <a:off x="3347864" y="35332"/>
            <a:ext cx="24208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Large fresh granule 1 SE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539552" y="476672"/>
            <a:ext cx="178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/ </a:t>
            </a:r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Hi = ACC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6660232" y="476672"/>
            <a:ext cx="1943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carbonate peak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491880" y="476672"/>
            <a:ext cx="164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calcite peak</a:t>
            </a:r>
            <a:endParaRPr lang="en-GB" dirty="0"/>
          </a:p>
        </p:txBody>
      </p:sp>
      <p:pic>
        <p:nvPicPr>
          <p:cNvPr id="4100" name="Picture 4" descr="X:\2014\sm9197-1\processing\Processed maps CaCO3\EW7 large fresh granule 1 SE corner\EW7 fresh large granule 1 SE corner 3 clusters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0" y="3068960"/>
            <a:ext cx="2051720" cy="1968417"/>
          </a:xfrm>
          <a:prstGeom prst="rect">
            <a:avLst/>
          </a:prstGeom>
          <a:noFill/>
        </p:spPr>
      </p:pic>
      <p:pic>
        <p:nvPicPr>
          <p:cNvPr id="4101" name="Picture 5" descr="X:\2014\sm9197-1\processing\Processed maps CaCO3\EW7 large fresh granule 1 SE corner\EW7 fresh large granule 1 SE corner 4 clusters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051720" y="3068961"/>
            <a:ext cx="2026495" cy="1944216"/>
          </a:xfrm>
          <a:prstGeom prst="rect">
            <a:avLst/>
          </a:prstGeom>
          <a:noFill/>
        </p:spPr>
      </p:pic>
      <p:sp>
        <p:nvSpPr>
          <p:cNvPr id="16" name="TextBox 15"/>
          <p:cNvSpPr txBox="1"/>
          <p:nvPr/>
        </p:nvSpPr>
        <p:spPr>
          <a:xfrm>
            <a:off x="5508104" y="5085184"/>
            <a:ext cx="562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CC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7596336" y="5085184"/>
            <a:ext cx="81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alcite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5868144" y="5445224"/>
            <a:ext cx="2314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omponent regression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43608" y="5445224"/>
            <a:ext cx="1619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luster analysis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611560" y="5085184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3 clusters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2915816" y="5013176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4 clusters</a:t>
            </a:r>
            <a:endParaRPr lang="en-GB" dirty="0"/>
          </a:p>
        </p:txBody>
      </p:sp>
      <p:pic>
        <p:nvPicPr>
          <p:cNvPr id="5122" name="Picture 2" descr="X:\2014\sm9197-1\processing\Processed maps CaCO3\EW7 large fresh granule 1 SE corner\EW7 fresh large granule 1 SE corner component regression ACC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355976" y="3068960"/>
            <a:ext cx="2158950" cy="2071293"/>
          </a:xfrm>
          <a:prstGeom prst="rect">
            <a:avLst/>
          </a:prstGeom>
          <a:noFill/>
        </p:spPr>
      </p:pic>
      <p:pic>
        <p:nvPicPr>
          <p:cNvPr id="5123" name="Picture 3" descr="X:\2014\sm9197-1\processing\Processed maps CaCO3\EW7 large fresh granule 1 SE corner\EW7 fresh large granule 1 SE corner component regression calcite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6588224" y="3068960"/>
            <a:ext cx="1981597" cy="1921366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84921"/>
            <a:ext cx="7772400" cy="1470025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40696"/>
            <a:ext cx="6400800" cy="1752600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3347864" y="35332"/>
            <a:ext cx="2149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Large fresh granule 2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539552" y="476672"/>
            <a:ext cx="178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/ </a:t>
            </a:r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Hi = ACC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6660232" y="476672"/>
            <a:ext cx="1943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carbonate peak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491880" y="476672"/>
            <a:ext cx="164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calcite peak</a:t>
            </a:r>
            <a:endParaRPr lang="en-GB" dirty="0"/>
          </a:p>
        </p:txBody>
      </p:sp>
      <p:pic>
        <p:nvPicPr>
          <p:cNvPr id="3074" name="Picture 2" descr="X:\2014\sm9197-1\processing\Processed maps CaCO3\EW7 fresh granule 2 whole granule\EW7 fresh granule 2 v2 over v4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7505" y="980729"/>
            <a:ext cx="2905080" cy="2088232"/>
          </a:xfrm>
          <a:prstGeom prst="rect">
            <a:avLst/>
          </a:prstGeom>
          <a:noFill/>
        </p:spPr>
      </p:pic>
      <p:pic>
        <p:nvPicPr>
          <p:cNvPr id="3075" name="Picture 3" descr="X:\2014\sm9197-1\processing\Processed maps CaCO3\EW7 fresh granule 2 whole granule\EW7 fresh granule 2 716 to 695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987824" y="980728"/>
            <a:ext cx="2804904" cy="2016224"/>
          </a:xfrm>
          <a:prstGeom prst="rect">
            <a:avLst/>
          </a:prstGeom>
          <a:noFill/>
        </p:spPr>
      </p:pic>
      <p:pic>
        <p:nvPicPr>
          <p:cNvPr id="3076" name="Picture 4" descr="X:\2014\sm9197-1\processing\Processed maps CaCO3\EW7 fresh granule 2 whole granule\EW7 fresh granule 2 890 to 855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012160" y="980728"/>
            <a:ext cx="3005255" cy="2160240"/>
          </a:xfrm>
          <a:prstGeom prst="rect">
            <a:avLst/>
          </a:prstGeom>
          <a:noFill/>
        </p:spPr>
      </p:pic>
      <p:pic>
        <p:nvPicPr>
          <p:cNvPr id="3077" name="Picture 5" descr="X:\2014\sm9197-1\processing\Processed maps CaCO3\EW7 fresh granule 2 whole granule\EW7 fresh granule 2 over view with grid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779912" y="5589240"/>
            <a:ext cx="1656184" cy="1174599"/>
          </a:xfrm>
          <a:prstGeom prst="rect">
            <a:avLst/>
          </a:prstGeom>
          <a:noFill/>
        </p:spPr>
      </p:pic>
      <p:pic>
        <p:nvPicPr>
          <p:cNvPr id="2050" name="Picture 2" descr="X:\2014\sm9197-1\processing\Processed maps CaCO3\EW7 fresh granule 2 whole granule\EW7 fresh granule 2 3 clusters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98364" y="3068960"/>
            <a:ext cx="2251660" cy="2160239"/>
          </a:xfrm>
          <a:prstGeom prst="rect">
            <a:avLst/>
          </a:prstGeom>
          <a:noFill/>
        </p:spPr>
      </p:pic>
      <p:pic>
        <p:nvPicPr>
          <p:cNvPr id="2051" name="Picture 3" descr="X:\2014\sm9197-1\processing\Processed maps CaCO3\EW7 fresh granule 2 whole granule\EW7 fresh granule 2 7 clusters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339751" y="3068960"/>
            <a:ext cx="2251661" cy="2160240"/>
          </a:xfrm>
          <a:prstGeom prst="rect">
            <a:avLst/>
          </a:prstGeom>
          <a:noFill/>
        </p:spPr>
      </p:pic>
      <p:sp>
        <p:nvSpPr>
          <p:cNvPr id="14" name="TextBox 13"/>
          <p:cNvSpPr txBox="1"/>
          <p:nvPr/>
        </p:nvSpPr>
        <p:spPr>
          <a:xfrm>
            <a:off x="5724128" y="5373216"/>
            <a:ext cx="562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CC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7812360" y="5373216"/>
            <a:ext cx="81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alcite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5868144" y="5733256"/>
            <a:ext cx="2314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omponent regression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1296718" y="5733256"/>
            <a:ext cx="1619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luster analysis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827584" y="5373216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3 clusters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3131840" y="5301208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7 clusters</a:t>
            </a:r>
            <a:endParaRPr lang="en-GB" dirty="0"/>
          </a:p>
        </p:txBody>
      </p:sp>
      <p:pic>
        <p:nvPicPr>
          <p:cNvPr id="2052" name="Picture 4" descr="X:\2014\sm9197-1\processing\Processed maps CaCO3\EW7 fresh granule 2 whole granule\EW7 fresh granule 2 component regression ACC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720304" y="3068961"/>
            <a:ext cx="2251660" cy="2160240"/>
          </a:xfrm>
          <a:prstGeom prst="rect">
            <a:avLst/>
          </a:prstGeom>
          <a:noFill/>
        </p:spPr>
      </p:pic>
      <p:pic>
        <p:nvPicPr>
          <p:cNvPr id="2053" name="Picture 5" descr="X:\2014\sm9197-1\processing\Processed maps CaCO3\EW7 fresh granule 2 whole granule\EW7 fresh granule 2 component regression calcite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6880544" y="3068960"/>
            <a:ext cx="2227960" cy="216024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84921"/>
            <a:ext cx="7772400" cy="1470025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40696"/>
            <a:ext cx="6400800" cy="1752600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3347864" y="35332"/>
            <a:ext cx="2805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Large fresh granule 2 centre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539552" y="476672"/>
            <a:ext cx="178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/ </a:t>
            </a:r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Hi = ACC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6660232" y="476672"/>
            <a:ext cx="1943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carbonate peak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491880" y="476672"/>
            <a:ext cx="164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calcite peak</a:t>
            </a:r>
            <a:endParaRPr lang="en-GB" dirty="0"/>
          </a:p>
        </p:txBody>
      </p:sp>
      <p:pic>
        <p:nvPicPr>
          <p:cNvPr id="4098" name="Picture 2" descr="X:\2014\sm9197-1\processing\Processed maps CaCO3\EW7 fresh granule 2 centre\EW7 fresh granule 2 middle v2 over v4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67543" y="908720"/>
            <a:ext cx="2504379" cy="1800200"/>
          </a:xfrm>
          <a:prstGeom prst="rect">
            <a:avLst/>
          </a:prstGeom>
          <a:noFill/>
        </p:spPr>
      </p:pic>
      <p:pic>
        <p:nvPicPr>
          <p:cNvPr id="4099" name="Picture 3" descr="X:\2014\sm9197-1\processing\Processed maps CaCO3\EW7 fresh granule 2 centre\EW7 fresh granule 2 middle 716 to 695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059832" y="908720"/>
            <a:ext cx="2597722" cy="1867297"/>
          </a:xfrm>
          <a:prstGeom prst="rect">
            <a:avLst/>
          </a:prstGeom>
          <a:noFill/>
        </p:spPr>
      </p:pic>
      <p:pic>
        <p:nvPicPr>
          <p:cNvPr id="4100" name="Picture 4" descr="X:\2014\sm9197-1\processing\Processed maps CaCO3\EW7 fresh granule 2 centre\EW7 fresh granule 2 middle 890 to 855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012160" y="836712"/>
            <a:ext cx="2832373" cy="2035969"/>
          </a:xfrm>
          <a:prstGeom prst="rect">
            <a:avLst/>
          </a:prstGeom>
          <a:noFill/>
        </p:spPr>
      </p:pic>
      <p:pic>
        <p:nvPicPr>
          <p:cNvPr id="1027" name="Picture 3" descr="X:\2014\sm9197-1\processing\Processed maps CaCO3\EW7 fresh granule 2 centre\EW7 fresh granule 2 middle 6 clusters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411761" y="2780929"/>
            <a:ext cx="2326716" cy="2232248"/>
          </a:xfrm>
          <a:prstGeom prst="rect">
            <a:avLst/>
          </a:prstGeom>
          <a:noFill/>
        </p:spPr>
      </p:pic>
      <p:pic>
        <p:nvPicPr>
          <p:cNvPr id="1029" name="Picture 5" descr="X:\2014\sm9197-1\processing\Processed maps CaCO3\EW7 fresh granule 2 centre\EW7 fresh granule 2 middle 3 clusters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" y="2780928"/>
            <a:ext cx="2326716" cy="2232248"/>
          </a:xfrm>
          <a:prstGeom prst="rect">
            <a:avLst/>
          </a:prstGeom>
          <a:noFill/>
        </p:spPr>
      </p:pic>
      <p:pic>
        <p:nvPicPr>
          <p:cNvPr id="1030" name="Picture 6" descr="X:\2014\sm9197-1\processing\Processed maps CaCO3\EW7 fresh granule 2 centre\EW7 fresh granule 2 middle component regression ACC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644008" y="2780928"/>
            <a:ext cx="2304256" cy="2234218"/>
          </a:xfrm>
          <a:prstGeom prst="rect">
            <a:avLst/>
          </a:prstGeom>
          <a:noFill/>
        </p:spPr>
      </p:pic>
      <p:sp>
        <p:nvSpPr>
          <p:cNvPr id="18" name="TextBox 17"/>
          <p:cNvSpPr txBox="1"/>
          <p:nvPr/>
        </p:nvSpPr>
        <p:spPr>
          <a:xfrm>
            <a:off x="5508104" y="5085184"/>
            <a:ext cx="562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CC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7596336" y="5085184"/>
            <a:ext cx="81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alcite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5868144" y="5445224"/>
            <a:ext cx="2314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omponent regression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1043608" y="5445224"/>
            <a:ext cx="1619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luster analysis</a:t>
            </a:r>
            <a:endParaRPr lang="en-GB" dirty="0"/>
          </a:p>
        </p:txBody>
      </p:sp>
      <p:sp>
        <p:nvSpPr>
          <p:cNvPr id="22" name="TextBox 21"/>
          <p:cNvSpPr txBox="1"/>
          <p:nvPr/>
        </p:nvSpPr>
        <p:spPr>
          <a:xfrm>
            <a:off x="611560" y="5085184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3 clusters</a:t>
            </a:r>
            <a:endParaRPr lang="en-GB" dirty="0"/>
          </a:p>
        </p:txBody>
      </p:sp>
      <p:sp>
        <p:nvSpPr>
          <p:cNvPr id="23" name="TextBox 22"/>
          <p:cNvSpPr txBox="1"/>
          <p:nvPr/>
        </p:nvSpPr>
        <p:spPr>
          <a:xfrm>
            <a:off x="2915816" y="5013176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6 clusters</a:t>
            </a:r>
            <a:endParaRPr lang="en-GB" dirty="0"/>
          </a:p>
        </p:txBody>
      </p:sp>
      <p:pic>
        <p:nvPicPr>
          <p:cNvPr id="2051" name="Picture 3" descr="X:\2014\sm9197-1\processing\Processed maps CaCO3\EW7 fresh granule 2 centre\EW7 fresh granule 2 middle component regression calcite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6766867" y="2812533"/>
            <a:ext cx="2269629" cy="2200643"/>
          </a:xfrm>
          <a:prstGeom prst="rect">
            <a:avLst/>
          </a:prstGeom>
          <a:noFill/>
        </p:spPr>
      </p:pic>
      <p:pic>
        <p:nvPicPr>
          <p:cNvPr id="2050" name="Picture 2" descr="X:\2014\sm9197-1\processing\Processed maps CaCO3\EW7 fresh granule 2 centre\EW7 fresh granule 2 middle overview map with grid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995936" y="5301208"/>
            <a:ext cx="1351358" cy="1310283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84921"/>
            <a:ext cx="7772400" cy="1470025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40696"/>
            <a:ext cx="6400800" cy="1752600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3347864" y="35332"/>
            <a:ext cx="1441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ld granule 1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539552" y="476672"/>
            <a:ext cx="178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/ </a:t>
            </a:r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Hi = ACC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6660232" y="476672"/>
            <a:ext cx="1943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carbonate peak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491880" y="476672"/>
            <a:ext cx="164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calcite peak</a:t>
            </a:r>
            <a:endParaRPr lang="en-GB" dirty="0"/>
          </a:p>
        </p:txBody>
      </p:sp>
      <p:pic>
        <p:nvPicPr>
          <p:cNvPr id="5122" name="Picture 2" descr="X:\2014\sm9197-1\processing\Processed maps CaCO3\EW7 old granules granule 1 whole granule\EW7 old granules granule 1 v2v4 ratio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95536" y="1052736"/>
            <a:ext cx="2601858" cy="1886347"/>
          </a:xfrm>
          <a:prstGeom prst="rect">
            <a:avLst/>
          </a:prstGeom>
          <a:noFill/>
        </p:spPr>
      </p:pic>
      <p:pic>
        <p:nvPicPr>
          <p:cNvPr id="5123" name="Picture 3" descr="X:\2014\sm9197-1\processing\Processed maps CaCO3\EW7 old granules granule 1 whole granule\EW7 old granules granule 1 716 to 695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059832" y="980728"/>
            <a:ext cx="2750840" cy="1994359"/>
          </a:xfrm>
          <a:prstGeom prst="rect">
            <a:avLst/>
          </a:prstGeom>
          <a:noFill/>
        </p:spPr>
      </p:pic>
      <p:pic>
        <p:nvPicPr>
          <p:cNvPr id="5124" name="Picture 4" descr="X:\2014\sm9197-1\processing\Processed maps CaCO3\EW7 old granules granule 1 whole granule\EW7 old granules granule 1 890 to 855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084168" y="980728"/>
            <a:ext cx="2736304" cy="1983821"/>
          </a:xfrm>
          <a:prstGeom prst="rect">
            <a:avLst/>
          </a:prstGeom>
          <a:noFill/>
        </p:spPr>
      </p:pic>
      <p:pic>
        <p:nvPicPr>
          <p:cNvPr id="7170" name="Picture 2" descr="X:\2014\sm9197-1\processing\Processed maps CaCO3\EW7 old granules granule 1 whole granule\EW7 old granules granule 1 3 clusters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23528" y="2924944"/>
            <a:ext cx="1951438" cy="1872207"/>
          </a:xfrm>
          <a:prstGeom prst="rect">
            <a:avLst/>
          </a:prstGeom>
          <a:noFill/>
        </p:spPr>
      </p:pic>
      <p:pic>
        <p:nvPicPr>
          <p:cNvPr id="7171" name="Picture 3" descr="X:\2014\sm9197-1\processing\Processed maps CaCO3\EW7 old granules granule 1 whole granule\EW7 old granules granule 1 5 clusters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267744" y="2996952"/>
            <a:ext cx="1876384" cy="1800200"/>
          </a:xfrm>
          <a:prstGeom prst="rect">
            <a:avLst/>
          </a:prstGeom>
          <a:noFill/>
        </p:spPr>
      </p:pic>
      <p:sp>
        <p:nvSpPr>
          <p:cNvPr id="14" name="TextBox 13"/>
          <p:cNvSpPr txBox="1"/>
          <p:nvPr/>
        </p:nvSpPr>
        <p:spPr>
          <a:xfrm>
            <a:off x="5508104" y="5085184"/>
            <a:ext cx="562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CC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7596336" y="5085184"/>
            <a:ext cx="81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alcite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5868144" y="5445224"/>
            <a:ext cx="2314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omponent regression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1043608" y="5445224"/>
            <a:ext cx="1619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luster analysis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611560" y="5085184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3 clusters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2915816" y="5013176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5 clusters</a:t>
            </a:r>
            <a:endParaRPr lang="en-GB" dirty="0"/>
          </a:p>
        </p:txBody>
      </p:sp>
      <p:pic>
        <p:nvPicPr>
          <p:cNvPr id="7172" name="Picture 4" descr="X:\2014\sm9197-1\processing\Processed maps CaCO3\EW7 old granules granule 1 whole granule\EW7 old granules granule 1 component regression ACC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139952" y="3068960"/>
            <a:ext cx="2016224" cy="1934362"/>
          </a:xfrm>
          <a:prstGeom prst="rect">
            <a:avLst/>
          </a:prstGeom>
          <a:noFill/>
        </p:spPr>
      </p:pic>
      <p:pic>
        <p:nvPicPr>
          <p:cNvPr id="7173" name="Picture 5" descr="X:\2014\sm9197-1\processing\Processed maps CaCO3\EW7 old granules granule 1 whole granule\EW7 old granules granule 1 component regression calcite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6300192" y="3068960"/>
            <a:ext cx="2016224" cy="1954940"/>
          </a:xfrm>
          <a:prstGeom prst="rect">
            <a:avLst/>
          </a:prstGeom>
          <a:noFill/>
        </p:spPr>
      </p:pic>
      <p:pic>
        <p:nvPicPr>
          <p:cNvPr id="4" name="Picture 2" descr="X:\2014\sm9197-1\processing\Processed maps CaCO3\EW7 old granules granule 1 whole granule\EW7 old granules granule 1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923928" y="5085184"/>
            <a:ext cx="1621557" cy="157227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84921"/>
            <a:ext cx="7772400" cy="1470025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40696"/>
            <a:ext cx="6400800" cy="1752600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3347864" y="35332"/>
            <a:ext cx="23714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ld granule 1 N narrow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539552" y="476672"/>
            <a:ext cx="178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/ </a:t>
            </a:r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Hi = ACC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6660232" y="476672"/>
            <a:ext cx="1943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carbonate peak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491880" y="476672"/>
            <a:ext cx="164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calcite peak</a:t>
            </a:r>
            <a:endParaRPr lang="en-GB" dirty="0"/>
          </a:p>
        </p:txBody>
      </p:sp>
      <p:pic>
        <p:nvPicPr>
          <p:cNvPr id="6146" name="Picture 2" descr="X:\2014\sm9197-1\processing\Processed maps CaCO3\EW7 old graunle 1 N\slim version\EW7 old granule 1 N v2v4 ratio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95536" y="908720"/>
            <a:ext cx="2880320" cy="2088232"/>
          </a:xfrm>
          <a:prstGeom prst="rect">
            <a:avLst/>
          </a:prstGeom>
          <a:noFill/>
        </p:spPr>
      </p:pic>
      <p:pic>
        <p:nvPicPr>
          <p:cNvPr id="6147" name="Picture 3" descr="X:\2014\sm9197-1\processing\Processed maps CaCO3\EW7 old graunle 1 N\slim version\EW7 old granule 1 N 716 to 695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275856" y="908720"/>
            <a:ext cx="2880320" cy="2088232"/>
          </a:xfrm>
          <a:prstGeom prst="rect">
            <a:avLst/>
          </a:prstGeom>
          <a:noFill/>
        </p:spPr>
      </p:pic>
      <p:pic>
        <p:nvPicPr>
          <p:cNvPr id="6148" name="Picture 4" descr="X:\2014\sm9197-1\processing\Processed maps CaCO3\EW7 old graunle 1 N\slim version\EW7 old granule 1 N 890 to 855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105128" y="908720"/>
            <a:ext cx="3038872" cy="2203182"/>
          </a:xfrm>
          <a:prstGeom prst="rect">
            <a:avLst/>
          </a:prstGeom>
          <a:noFill/>
        </p:spPr>
      </p:pic>
      <p:pic>
        <p:nvPicPr>
          <p:cNvPr id="9218" name="Picture 2" descr="X:\2014\sm9197-1\processing\Processed maps CaCO3\EW7 old graunle 1 N\slim version\EW7 old granule 1 N 3 clusters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39552" y="3212977"/>
            <a:ext cx="1501107" cy="1440160"/>
          </a:xfrm>
          <a:prstGeom prst="rect">
            <a:avLst/>
          </a:prstGeom>
          <a:noFill/>
        </p:spPr>
      </p:pic>
      <p:pic>
        <p:nvPicPr>
          <p:cNvPr id="9219" name="Picture 3" descr="X:\2014\sm9197-1\processing\Processed maps CaCO3\EW7 old graunle 1 N\slim version\EW7 old granule 1 N 5 clusters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339752" y="3212976"/>
            <a:ext cx="1576163" cy="1512168"/>
          </a:xfrm>
          <a:prstGeom prst="rect">
            <a:avLst/>
          </a:prstGeom>
          <a:noFill/>
        </p:spPr>
      </p:pic>
      <p:sp>
        <p:nvSpPr>
          <p:cNvPr id="13" name="TextBox 12"/>
          <p:cNvSpPr txBox="1"/>
          <p:nvPr/>
        </p:nvSpPr>
        <p:spPr>
          <a:xfrm>
            <a:off x="5508104" y="5085184"/>
            <a:ext cx="562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CC</a:t>
            </a:r>
            <a:endParaRPr lang="en-GB" dirty="0"/>
          </a:p>
        </p:txBody>
      </p:sp>
      <p:sp>
        <p:nvSpPr>
          <p:cNvPr id="14" name="TextBox 13"/>
          <p:cNvSpPr txBox="1"/>
          <p:nvPr/>
        </p:nvSpPr>
        <p:spPr>
          <a:xfrm>
            <a:off x="7596336" y="5085184"/>
            <a:ext cx="81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alcite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5868144" y="5445224"/>
            <a:ext cx="2314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omponent regression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1043608" y="5445224"/>
            <a:ext cx="1619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luster analysis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611560" y="5085184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3 clusters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2915816" y="5013176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5 clusters</a:t>
            </a:r>
            <a:endParaRPr lang="en-GB" dirty="0"/>
          </a:p>
        </p:txBody>
      </p:sp>
      <p:pic>
        <p:nvPicPr>
          <p:cNvPr id="4098" name="Picture 2" descr="X:\2014\sm9197-1\processing\Processed maps CaCO3\EW7 old graunle 1 N\slim version\EW7 old granule 1 N component regression ACC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932040" y="3284983"/>
            <a:ext cx="1942926" cy="1864041"/>
          </a:xfrm>
          <a:prstGeom prst="rect">
            <a:avLst/>
          </a:prstGeom>
          <a:noFill/>
        </p:spPr>
      </p:pic>
      <p:pic>
        <p:nvPicPr>
          <p:cNvPr id="4099" name="Picture 3" descr="X:\2014\sm9197-1\processing\Processed maps CaCO3\EW7 old graunle 1 N\slim version\EW7 old granule 1 N component regression calcite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6948264" y="3284984"/>
            <a:ext cx="1909589" cy="1851547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84921"/>
            <a:ext cx="7772400" cy="1470025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40696"/>
            <a:ext cx="6400800" cy="1752600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3347864" y="35332"/>
            <a:ext cx="21516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ld granule 1 N wide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539552" y="476672"/>
            <a:ext cx="178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/ </a:t>
            </a:r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Hi = ACC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6660232" y="476672"/>
            <a:ext cx="1943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carbonate peak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491880" y="476672"/>
            <a:ext cx="164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calcite peak</a:t>
            </a:r>
            <a:endParaRPr lang="en-GB" dirty="0"/>
          </a:p>
        </p:txBody>
      </p:sp>
      <p:sp>
        <p:nvSpPr>
          <p:cNvPr id="14" name="TextBox 13"/>
          <p:cNvSpPr txBox="1"/>
          <p:nvPr/>
        </p:nvSpPr>
        <p:spPr>
          <a:xfrm>
            <a:off x="5508104" y="5085184"/>
            <a:ext cx="562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CC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7596336" y="5085184"/>
            <a:ext cx="81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alcite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5868144" y="5445224"/>
            <a:ext cx="2314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omponent regression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1043608" y="5445224"/>
            <a:ext cx="1619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luster analysis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611560" y="5085184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3 clusters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2555776" y="5157192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5 clusters</a:t>
            </a:r>
            <a:endParaRPr lang="en-GB" dirty="0"/>
          </a:p>
        </p:txBody>
      </p:sp>
      <p:pic>
        <p:nvPicPr>
          <p:cNvPr id="6146" name="Picture 2" descr="X:\2014\sm9197-1\processing\Processed maps CaCO3\EW7 old graunle 1 N\wider version\EW7 old granule 1 N v2v4 ratio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3568" y="908720"/>
            <a:ext cx="2041232" cy="1958355"/>
          </a:xfrm>
          <a:prstGeom prst="rect">
            <a:avLst/>
          </a:prstGeom>
          <a:noFill/>
        </p:spPr>
      </p:pic>
      <p:pic>
        <p:nvPicPr>
          <p:cNvPr id="6147" name="Picture 3" descr="X:\2014\sm9197-1\processing\Processed maps CaCO3\EW7 old graunle 1 N\wider version\EW7 old granule 1 N 716 to 695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347864" y="836712"/>
            <a:ext cx="2191343" cy="2102371"/>
          </a:xfrm>
          <a:prstGeom prst="rect">
            <a:avLst/>
          </a:prstGeom>
          <a:noFill/>
        </p:spPr>
      </p:pic>
      <p:pic>
        <p:nvPicPr>
          <p:cNvPr id="6148" name="Picture 4" descr="X:\2014\sm9197-1\processing\Processed maps CaCO3\EW7 old graunle 1 N\wider version\EW7 old granule 1 N 890 to 855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516216" y="836713"/>
            <a:ext cx="2293824" cy="2200692"/>
          </a:xfrm>
          <a:prstGeom prst="rect">
            <a:avLst/>
          </a:prstGeom>
          <a:noFill/>
        </p:spPr>
      </p:pic>
      <p:pic>
        <p:nvPicPr>
          <p:cNvPr id="6149" name="Picture 5" descr="X:\2014\sm9197-1\processing\Processed maps CaCO3\EW7 old graunle 1 N\wider version\EW7 old granule 1 N 3 clusters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39552" y="2996952"/>
            <a:ext cx="2116287" cy="2030363"/>
          </a:xfrm>
          <a:prstGeom prst="rect">
            <a:avLst/>
          </a:prstGeom>
          <a:noFill/>
        </p:spPr>
      </p:pic>
      <p:pic>
        <p:nvPicPr>
          <p:cNvPr id="6150" name="Picture 6" descr="X:\2014\sm9197-1\processing\Processed maps CaCO3\EW7 old graunle 1 N\wider version\EW7 old granule 1 N 5 clusters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843808" y="2996952"/>
            <a:ext cx="2041232" cy="1958355"/>
          </a:xfrm>
          <a:prstGeom prst="rect">
            <a:avLst/>
          </a:prstGeom>
          <a:noFill/>
        </p:spPr>
      </p:pic>
      <p:pic>
        <p:nvPicPr>
          <p:cNvPr id="6151" name="Picture 7" descr="X:\2014\sm9197-1\processing\Processed maps CaCO3\EW7 old graunle 1 N\wider version\EW7 old granule 1 N component regression ACC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004048" y="2996952"/>
            <a:ext cx="2116287" cy="2030363"/>
          </a:xfrm>
          <a:prstGeom prst="rect">
            <a:avLst/>
          </a:prstGeom>
          <a:noFill/>
        </p:spPr>
      </p:pic>
      <p:pic>
        <p:nvPicPr>
          <p:cNvPr id="6152" name="Picture 8" descr="X:\2014\sm9197-1\processing\Processed maps CaCO3\EW7 old graunle 1 N\wider version\EW7 old granule 1 N component regression calcite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7177823" y="3068960"/>
            <a:ext cx="1966177" cy="1886347"/>
          </a:xfrm>
          <a:prstGeom prst="rect">
            <a:avLst/>
          </a:prstGeom>
          <a:noFill/>
        </p:spPr>
      </p:pic>
      <p:pic>
        <p:nvPicPr>
          <p:cNvPr id="6153" name="Picture 9" descr="X:\2014\sm9197-1\processing\Processed maps CaCO3\EW7 old graunle 1 N\wider version\EW7 old granule 1 N with grid for HR map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707904" y="5085184"/>
            <a:ext cx="1605594" cy="1556792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84921"/>
            <a:ext cx="7772400" cy="1470025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340696"/>
            <a:ext cx="6400800" cy="1752600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3347864" y="35332"/>
            <a:ext cx="1441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Old granule 2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539552" y="476672"/>
            <a:ext cx="17827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/ </a:t>
            </a:r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Hi = ACC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6660232" y="476672"/>
            <a:ext cx="19430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</a:t>
            </a:r>
            <a:r>
              <a:rPr lang="en-GB" dirty="0" smtClean="0"/>
              <a:t>2 carbonate peak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3491880" y="476672"/>
            <a:ext cx="1645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sym typeface="Symbol"/>
              </a:rPr>
              <a:t> </a:t>
            </a:r>
            <a:r>
              <a:rPr lang="en-GB" dirty="0" smtClean="0"/>
              <a:t>4 calcite peak</a:t>
            </a:r>
            <a:endParaRPr lang="en-GB" dirty="0"/>
          </a:p>
        </p:txBody>
      </p:sp>
      <p:pic>
        <p:nvPicPr>
          <p:cNvPr id="8194" name="Picture 2" descr="X:\2014\sm9197-1\processing\Processed maps CaCO3\EW7 old granules granule 2 whole granule\EW7 old granule 2 whole map v2v4 ratio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496" y="908721"/>
            <a:ext cx="2979641" cy="2160240"/>
          </a:xfrm>
          <a:prstGeom prst="rect">
            <a:avLst/>
          </a:prstGeom>
          <a:noFill/>
        </p:spPr>
      </p:pic>
      <p:pic>
        <p:nvPicPr>
          <p:cNvPr id="8195" name="Picture 3" descr="X:\2014\sm9197-1\processing\Processed maps CaCO3\EW7 old granules granule 2 whole granule\EW7 old granule 2 whole map 716 to 695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843809" y="908721"/>
            <a:ext cx="2880320" cy="2088232"/>
          </a:xfrm>
          <a:prstGeom prst="rect">
            <a:avLst/>
          </a:prstGeom>
          <a:noFill/>
        </p:spPr>
      </p:pic>
      <p:pic>
        <p:nvPicPr>
          <p:cNvPr id="8196" name="Picture 4" descr="X:\2014\sm9197-1\processing\Processed maps CaCO3\EW7 old granules granule 2 whole granule\EW7 old granule 2 whole map 890 to 855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781600" y="908720"/>
            <a:ext cx="2979641" cy="2160240"/>
          </a:xfrm>
          <a:prstGeom prst="rect">
            <a:avLst/>
          </a:prstGeom>
          <a:noFill/>
        </p:spPr>
      </p:pic>
      <p:pic>
        <p:nvPicPr>
          <p:cNvPr id="8197" name="Picture 5" descr="X:\2014\sm9197-1\processing\Processed maps CaCO3\EW7 old granules granule 2 whole granule\EW7 old granule 2 whole map with grid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347864" y="5341553"/>
            <a:ext cx="1872208" cy="1327807"/>
          </a:xfrm>
          <a:prstGeom prst="rect">
            <a:avLst/>
          </a:prstGeom>
          <a:noFill/>
        </p:spPr>
      </p:pic>
      <p:pic>
        <p:nvPicPr>
          <p:cNvPr id="5" name="Picture 3" descr="X:\2014\sm9197-1\processing\Processed maps CaCO3\EW7 old granules granule 2 whole granule\EW7 old granule 2 whole map 3 clusters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07504" y="3140968"/>
            <a:ext cx="1951439" cy="1872208"/>
          </a:xfrm>
          <a:prstGeom prst="rect">
            <a:avLst/>
          </a:prstGeom>
          <a:noFill/>
        </p:spPr>
      </p:pic>
      <p:pic>
        <p:nvPicPr>
          <p:cNvPr id="6" name="Picture 4" descr="X:\2014\sm9197-1\processing\Processed maps CaCO3\EW7 old granules granule 2 whole granule\EW7 old granule 2 whole map 4 clusters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123728" y="3140969"/>
            <a:ext cx="1951439" cy="1872208"/>
          </a:xfrm>
          <a:prstGeom prst="rect">
            <a:avLst/>
          </a:prstGeom>
          <a:noFill/>
        </p:spPr>
      </p:pic>
      <p:sp>
        <p:nvSpPr>
          <p:cNvPr id="15" name="TextBox 14"/>
          <p:cNvSpPr txBox="1"/>
          <p:nvPr/>
        </p:nvSpPr>
        <p:spPr>
          <a:xfrm>
            <a:off x="5508104" y="5085184"/>
            <a:ext cx="562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CC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7596336" y="5085184"/>
            <a:ext cx="8121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alcite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5868144" y="5445224"/>
            <a:ext cx="2314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omponent regression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1043608" y="5445224"/>
            <a:ext cx="1619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luster analysis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611560" y="5085184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3 clusters</a:t>
            </a:r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2915816" y="5013176"/>
            <a:ext cx="1070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4 clusters</a:t>
            </a:r>
            <a:endParaRPr lang="en-GB" dirty="0"/>
          </a:p>
        </p:txBody>
      </p:sp>
      <p:pic>
        <p:nvPicPr>
          <p:cNvPr id="8198" name="Picture 6" descr="X:\2014\sm9197-1\processing\Processed maps CaCO3\EW7 old granules granule 2 whole granule\EW7 old granule 2 whole map component regression ACC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067944" y="3140968"/>
            <a:ext cx="1966177" cy="1886347"/>
          </a:xfrm>
          <a:prstGeom prst="rect">
            <a:avLst/>
          </a:prstGeom>
          <a:noFill/>
        </p:spPr>
      </p:pic>
      <p:pic>
        <p:nvPicPr>
          <p:cNvPr id="8199" name="Picture 7" descr="X:\2014\sm9197-1\processing\Processed maps CaCO3\EW7 old granules granule 2 whole granule\EW7 old granule 2 whole map component regression calcite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5940152" y="3140969"/>
            <a:ext cx="1930898" cy="1872208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4</TotalTime>
  <Words>303</Words>
  <Application>Microsoft Office PowerPoint</Application>
  <PresentationFormat>On-screen Show (4:3)</PresentationFormat>
  <Paragraphs>100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uthorised Us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hh73367</dc:creator>
  <cp:lastModifiedBy>meh519</cp:lastModifiedBy>
  <cp:revision>43</cp:revision>
  <dcterms:created xsi:type="dcterms:W3CDTF">2014-02-21T09:57:18Z</dcterms:created>
  <dcterms:modified xsi:type="dcterms:W3CDTF">2015-04-23T19:26:12Z</dcterms:modified>
</cp:coreProperties>
</file>